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5" r:id="rId2"/>
  </p:sldIdLst>
  <p:sldSz cx="12192000" cy="6858000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999FF"/>
    <a:srgbClr val="0000FF"/>
    <a:srgbClr val="FF33CC"/>
    <a:srgbClr val="FFC000"/>
    <a:srgbClr val="FFCC99"/>
    <a:srgbClr val="00CCFF"/>
    <a:srgbClr val="6699FF"/>
    <a:srgbClr val="6666FF"/>
    <a:srgbClr val="99CCFF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629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5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67D377B7-C823-472C-9E09-6D86554DC02C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24F9BC96-858B-41C2-877C-3E56BFBCC5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778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2073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4889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9687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2090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4784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51218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6452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0106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29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5653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60492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D49D28-F927-4E46-A253-E492876AE6B2}" type="datetimeFigureOut">
              <a:rPr lang="en-US" smtClean="0"/>
              <a:t>5/3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916DA-E2D0-49F9-BACE-4E15C3BF5F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8365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Rectangle: Rounded Corners 91">
            <a:extLst>
              <a:ext uri="{FF2B5EF4-FFF2-40B4-BE49-F238E27FC236}">
                <a16:creationId xmlns:a16="http://schemas.microsoft.com/office/drawing/2014/main" id="{2CDECD03-F5B7-8B2E-3CFB-FA8304B26E4F}"/>
              </a:ext>
            </a:extLst>
          </p:cNvPr>
          <p:cNvSpPr/>
          <p:nvPr/>
        </p:nvSpPr>
        <p:spPr>
          <a:xfrm>
            <a:off x="1297713" y="1697661"/>
            <a:ext cx="5276088" cy="2065743"/>
          </a:xfrm>
          <a:prstGeom prst="round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3" name="Rectangle: Rounded Corners 92">
            <a:extLst>
              <a:ext uri="{FF2B5EF4-FFF2-40B4-BE49-F238E27FC236}">
                <a16:creationId xmlns:a16="http://schemas.microsoft.com/office/drawing/2014/main" id="{03A79A92-BE39-9EC8-A244-DCCCB3EF33FC}"/>
              </a:ext>
            </a:extLst>
          </p:cNvPr>
          <p:cNvSpPr/>
          <p:nvPr/>
        </p:nvSpPr>
        <p:spPr>
          <a:xfrm>
            <a:off x="1297713" y="3828688"/>
            <a:ext cx="5275207" cy="2815923"/>
          </a:xfrm>
          <a:prstGeom prst="roundRect">
            <a:avLst/>
          </a:prstGeom>
          <a:solidFill>
            <a:schemeClr val="bg1">
              <a:lumMod val="95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: Rounded Corners 90">
            <a:extLst>
              <a:ext uri="{FF2B5EF4-FFF2-40B4-BE49-F238E27FC236}">
                <a16:creationId xmlns:a16="http://schemas.microsoft.com/office/drawing/2014/main" id="{F51C66E5-3734-E44D-55A8-0790C42DF622}"/>
              </a:ext>
            </a:extLst>
          </p:cNvPr>
          <p:cNvSpPr/>
          <p:nvPr/>
        </p:nvSpPr>
        <p:spPr>
          <a:xfrm>
            <a:off x="1297713" y="256419"/>
            <a:ext cx="5276088" cy="1375959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 descr="A picture containing screenshot, child art, text, design&#10;&#10;Description automatically generated">
            <a:extLst>
              <a:ext uri="{FF2B5EF4-FFF2-40B4-BE49-F238E27FC236}">
                <a16:creationId xmlns:a16="http://schemas.microsoft.com/office/drawing/2014/main" id="{6D9FD53C-A012-B56C-8D2F-A13F0FA4926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clrChange>
              <a:clrFrom>
                <a:srgbClr val="FFFFFF"/>
              </a:clrFrom>
              <a:clrTo>
                <a:srgbClr val="FFF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7" r="38126" b="26934"/>
          <a:stretch/>
        </p:blipFill>
        <p:spPr>
          <a:xfrm>
            <a:off x="1297714" y="414168"/>
            <a:ext cx="4243285" cy="4813541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3D3A41AB-B4C5-00D8-68C2-07C3EA975697}"/>
              </a:ext>
            </a:extLst>
          </p:cNvPr>
          <p:cNvSpPr txBox="1"/>
          <p:nvPr/>
        </p:nvSpPr>
        <p:spPr>
          <a:xfrm>
            <a:off x="2977973" y="578324"/>
            <a:ext cx="86576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Untreated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5D7F36A-6277-9DBB-46F4-02269F577AFF}"/>
              </a:ext>
            </a:extLst>
          </p:cNvPr>
          <p:cNvSpPr txBox="1"/>
          <p:nvPr/>
        </p:nvSpPr>
        <p:spPr>
          <a:xfrm>
            <a:off x="3745648" y="578324"/>
            <a:ext cx="75875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uba-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772900A-5106-B6C0-7769-7146F333A170}"/>
              </a:ext>
            </a:extLst>
          </p:cNvPr>
          <p:cNvSpPr txBox="1"/>
          <p:nvPr/>
        </p:nvSpPr>
        <p:spPr>
          <a:xfrm>
            <a:off x="4406318" y="578324"/>
            <a:ext cx="90305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CY-738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EC64038-77FA-E919-1B8A-0C5C51CBB249}"/>
              </a:ext>
            </a:extLst>
          </p:cNvPr>
          <p:cNvSpPr txBox="1"/>
          <p:nvPr/>
        </p:nvSpPr>
        <p:spPr>
          <a:xfrm>
            <a:off x="1527101" y="303495"/>
            <a:ext cx="259792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.G7-Ova Cells - Density: 500 x 10</a:t>
            </a:r>
            <a:r>
              <a:rPr lang="en-US" sz="11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6353435-B535-E22F-1F42-A47794EDEF8F}"/>
              </a:ext>
            </a:extLst>
          </p:cNvPr>
          <p:cNvSpPr txBox="1"/>
          <p:nvPr/>
        </p:nvSpPr>
        <p:spPr>
          <a:xfrm>
            <a:off x="4487409" y="2160170"/>
            <a:ext cx="210385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1/42 pan MHC-I antibody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56201B-064E-6E1B-0C66-71D1D0638A70}"/>
              </a:ext>
            </a:extLst>
          </p:cNvPr>
          <p:cNvSpPr txBox="1"/>
          <p:nvPr/>
        </p:nvSpPr>
        <p:spPr>
          <a:xfrm>
            <a:off x="4244583" y="3231580"/>
            <a:ext cx="1331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eptid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C209294-9E77-2391-C010-2745313ED414}"/>
              </a:ext>
            </a:extLst>
          </p:cNvPr>
          <p:cNvSpPr txBox="1"/>
          <p:nvPr/>
        </p:nvSpPr>
        <p:spPr>
          <a:xfrm>
            <a:off x="1706034" y="3515013"/>
            <a:ext cx="1331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.G7-Ov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6ECA5D-E70D-C2F4-3847-90AD5B8E2DF7}"/>
              </a:ext>
            </a:extLst>
          </p:cNvPr>
          <p:cNvSpPr txBox="1"/>
          <p:nvPr/>
        </p:nvSpPr>
        <p:spPr>
          <a:xfrm>
            <a:off x="2370848" y="5033305"/>
            <a:ext cx="293852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Fusion Lumos Mass Spectrometer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C53D053-D922-D504-E045-67BB39AC1562}"/>
              </a:ext>
            </a:extLst>
          </p:cNvPr>
          <p:cNvSpPr txBox="1"/>
          <p:nvPr/>
        </p:nvSpPr>
        <p:spPr>
          <a:xfrm>
            <a:off x="4573416" y="2805814"/>
            <a:ext cx="133134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ow pH elutio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FB16311-6E52-76B7-208B-104DE11498CB}"/>
              </a:ext>
            </a:extLst>
          </p:cNvPr>
          <p:cNvSpPr txBox="1"/>
          <p:nvPr/>
        </p:nvSpPr>
        <p:spPr>
          <a:xfrm>
            <a:off x="1174384" y="5849344"/>
            <a:ext cx="1371600" cy="54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eptide Identification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24E7190-E582-EE21-25AB-72E9654995EC}"/>
              </a:ext>
            </a:extLst>
          </p:cNvPr>
          <p:cNvSpPr txBox="1"/>
          <p:nvPr/>
        </p:nvSpPr>
        <p:spPr>
          <a:xfrm>
            <a:off x="3843072" y="5826513"/>
            <a:ext cx="1371600" cy="54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inding sequence identification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7CDFF13-DC99-93C2-23E3-4D4F177C68C4}"/>
              </a:ext>
            </a:extLst>
          </p:cNvPr>
          <p:cNvSpPr txBox="1"/>
          <p:nvPr/>
        </p:nvSpPr>
        <p:spPr>
          <a:xfrm>
            <a:off x="2591121" y="5881642"/>
            <a:ext cx="1371600" cy="54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eptide Fold Change Quantification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B965B31-4AC2-D269-A7E2-1343FF15C832}"/>
              </a:ext>
            </a:extLst>
          </p:cNvPr>
          <p:cNvSpPr txBox="1"/>
          <p:nvPr/>
        </p:nvSpPr>
        <p:spPr>
          <a:xfrm>
            <a:off x="5219319" y="5837656"/>
            <a:ext cx="1372536" cy="5486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Peptide Motif Analysis</a:t>
            </a:r>
          </a:p>
        </p:txBody>
      </p: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2698D676-0750-2B6D-88C5-10334D4F2315}"/>
              </a:ext>
            </a:extLst>
          </p:cNvPr>
          <p:cNvCxnSpPr>
            <a:cxnSpLocks/>
          </p:cNvCxnSpPr>
          <p:nvPr/>
        </p:nvCxnSpPr>
        <p:spPr>
          <a:xfrm flipH="1">
            <a:off x="1941363" y="5285215"/>
            <a:ext cx="1728216" cy="512064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9E71BF8-BCAF-B871-5A12-1E418ECB0076}"/>
              </a:ext>
            </a:extLst>
          </p:cNvPr>
          <p:cNvCxnSpPr>
            <a:cxnSpLocks/>
          </p:cNvCxnSpPr>
          <p:nvPr/>
        </p:nvCxnSpPr>
        <p:spPr>
          <a:xfrm>
            <a:off x="4011526" y="5279729"/>
            <a:ext cx="1727327" cy="508697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6115F73B-20FE-D724-86C3-352433781DA0}"/>
              </a:ext>
            </a:extLst>
          </p:cNvPr>
          <p:cNvCxnSpPr>
            <a:cxnSpLocks/>
          </p:cNvCxnSpPr>
          <p:nvPr/>
        </p:nvCxnSpPr>
        <p:spPr>
          <a:xfrm flipH="1">
            <a:off x="3485254" y="5355833"/>
            <a:ext cx="316689" cy="493511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239BFA20-CF92-16D8-BB7C-F6778B0927B4}"/>
              </a:ext>
            </a:extLst>
          </p:cNvPr>
          <p:cNvCxnSpPr>
            <a:cxnSpLocks/>
          </p:cNvCxnSpPr>
          <p:nvPr/>
        </p:nvCxnSpPr>
        <p:spPr>
          <a:xfrm>
            <a:off x="3897325" y="5332172"/>
            <a:ext cx="320040" cy="493776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EF5A4F24-0564-E15F-9244-4962144AE4BB}"/>
              </a:ext>
            </a:extLst>
          </p:cNvPr>
          <p:cNvCxnSpPr>
            <a:cxnSpLocks/>
          </p:cNvCxnSpPr>
          <p:nvPr/>
        </p:nvCxnSpPr>
        <p:spPr>
          <a:xfrm>
            <a:off x="2805471" y="1226781"/>
            <a:ext cx="464680" cy="0"/>
          </a:xfrm>
          <a:prstGeom prst="straightConnector1">
            <a:avLst/>
          </a:prstGeom>
          <a:ln w="1905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4" name="TextBox 93">
            <a:extLst>
              <a:ext uri="{FF2B5EF4-FFF2-40B4-BE49-F238E27FC236}">
                <a16:creationId xmlns:a16="http://schemas.microsoft.com/office/drawing/2014/main" id="{01D035FA-FB1B-1323-3CA1-4A272FD1D22A}"/>
              </a:ext>
            </a:extLst>
          </p:cNvPr>
          <p:cNvSpPr txBox="1"/>
          <p:nvPr/>
        </p:nvSpPr>
        <p:spPr>
          <a:xfrm>
            <a:off x="6696249" y="528899"/>
            <a:ext cx="41423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ell Treatment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.G7-Ova cells were treated with the HDAC6 inhibitors at 1mM concentration for 72 h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7E9BEDEB-2234-C9CB-9A8A-30D3BD2AEADB}"/>
              </a:ext>
            </a:extLst>
          </p:cNvPr>
          <p:cNvSpPr txBox="1"/>
          <p:nvPr/>
        </p:nvSpPr>
        <p:spPr>
          <a:xfrm>
            <a:off x="6696248" y="2227924"/>
            <a:ext cx="459533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Immunoprecipitation (IP)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pellets were shipped to M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Biowork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here they wer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IP’d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with pan MHC-I M1/42 antibody and bound peptides were eluted at a low pH 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AD17803-DCB7-AC88-EA38-CF0380DB946C}"/>
              </a:ext>
            </a:extLst>
          </p:cNvPr>
          <p:cNvSpPr txBox="1"/>
          <p:nvPr/>
        </p:nvSpPr>
        <p:spPr>
          <a:xfrm>
            <a:off x="6696248" y="4617806"/>
            <a:ext cx="4696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Mass spectrometry data processing</a:t>
            </a:r>
          </a:p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luted peptides were analyzed by nano LC/MS/MS and data were processed using Skyline v22.2.0.255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43140" y="16901"/>
            <a:ext cx="9717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>
                <a:latin typeface="Arial" panose="020B0604020202020204" pitchFamily="34" charset="0"/>
                <a:cs typeface="Arial" panose="020B0604020202020204" pitchFamily="34" charset="0"/>
              </a:rPr>
              <a:t>Fig. S13</a:t>
            </a:r>
          </a:p>
        </p:txBody>
      </p:sp>
      <p:sp>
        <p:nvSpPr>
          <p:cNvPr id="2" name="Rectangle 1"/>
          <p:cNvSpPr/>
          <p:nvPr/>
        </p:nvSpPr>
        <p:spPr>
          <a:xfrm>
            <a:off x="6727841" y="5661999"/>
            <a:ext cx="46644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solidFill>
                  <a:srgbClr val="C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Fig. S13.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MS workflow used to identify MHC class I peptides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creased</a:t>
            </a:r>
          </a:p>
          <a:p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by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treatment with </a:t>
            </a:r>
            <a:r>
              <a:rPr lang="en-US" sz="120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HDAC6 </a:t>
            </a:r>
            <a:r>
              <a:rPr lang="en-US" sz="120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inhibitors or bortezomib.</a:t>
            </a:r>
            <a:r>
              <a:rPr lang="en-US" sz="1200" b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684041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</TotalTime>
  <Words>124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HH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iscoll, James Joseph</dc:creator>
  <cp:lastModifiedBy>Driscoll, James Joseph</cp:lastModifiedBy>
  <cp:revision>100</cp:revision>
  <cp:lastPrinted>2024-03-02T18:31:01Z</cp:lastPrinted>
  <dcterms:created xsi:type="dcterms:W3CDTF">2022-08-15T18:48:13Z</dcterms:created>
  <dcterms:modified xsi:type="dcterms:W3CDTF">2024-05-03T22:09:19Z</dcterms:modified>
</cp:coreProperties>
</file>